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0" r:id="rId3"/>
    <p:sldId id="262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C40EB41-7F30-B2AD-1567-F500D443E7B2}" name="Koesmahargyo, Vidya" initials="" userId="S::Vidya.Koesmahargyo@nyulangone.org::9ac5542d-4fc5-4ec3-92d8-d4b50dc7fb60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39"/>
    <p:restoredTop sz="94697"/>
  </p:normalViewPr>
  <p:slideViewPr>
    <p:cSldViewPr snapToGrid="0" snapToObjects="1">
      <p:cViewPr>
        <p:scale>
          <a:sx n="112" d="100"/>
          <a:sy n="112" d="100"/>
        </p:scale>
        <p:origin x="1120" y="-184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8/10/relationships/authors" Target="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487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865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411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540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530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436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953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22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596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59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995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F7C3F7-9F2C-EE4A-B62B-BCA05B0D1256}" type="datetimeFigureOut">
              <a:rPr lang="en-US" smtClean="0"/>
              <a:t>7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72B70-B3FA-234B-B9B2-4DD7D7C72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2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5BE5BB1-0B40-9945-BF84-4BA37F8CD6E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6617" y="360136"/>
            <a:ext cx="3855720" cy="621157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4778AE7-C178-1447-AEE1-C788B3B5D208}"/>
              </a:ext>
            </a:extLst>
          </p:cNvPr>
          <p:cNvSpPr txBox="1"/>
          <p:nvPr/>
        </p:nvSpPr>
        <p:spPr>
          <a:xfrm>
            <a:off x="197962" y="7244748"/>
            <a:ext cx="643850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498475" algn="l"/>
                <a:tab pos="2971800" algn="ctr"/>
              </a:tabLs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1: Model architecture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 diagram of the model architecture.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71042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AE024BC-2B19-5A08-334F-CEA6D67BBF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2863646"/>
              </p:ext>
            </p:extLst>
          </p:nvPr>
        </p:nvGraphicFramePr>
        <p:xfrm>
          <a:off x="83855" y="4934138"/>
          <a:ext cx="6690287" cy="3425866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931358">
                  <a:extLst>
                    <a:ext uri="{9D8B030D-6E8A-4147-A177-3AD203B41FA5}">
                      <a16:colId xmlns:a16="http://schemas.microsoft.com/office/drawing/2014/main" val="3594814983"/>
                    </a:ext>
                  </a:extLst>
                </a:gridCol>
                <a:gridCol w="719452">
                  <a:extLst>
                    <a:ext uri="{9D8B030D-6E8A-4147-A177-3AD203B41FA5}">
                      <a16:colId xmlns:a16="http://schemas.microsoft.com/office/drawing/2014/main" val="426336788"/>
                    </a:ext>
                  </a:extLst>
                </a:gridCol>
                <a:gridCol w="874644">
                  <a:extLst>
                    <a:ext uri="{9D8B030D-6E8A-4147-A177-3AD203B41FA5}">
                      <a16:colId xmlns:a16="http://schemas.microsoft.com/office/drawing/2014/main" val="427616702"/>
                    </a:ext>
                  </a:extLst>
                </a:gridCol>
                <a:gridCol w="936972">
                  <a:extLst>
                    <a:ext uri="{9D8B030D-6E8A-4147-A177-3AD203B41FA5}">
                      <a16:colId xmlns:a16="http://schemas.microsoft.com/office/drawing/2014/main" val="2586678968"/>
                    </a:ext>
                  </a:extLst>
                </a:gridCol>
                <a:gridCol w="764607">
                  <a:extLst>
                    <a:ext uri="{9D8B030D-6E8A-4147-A177-3AD203B41FA5}">
                      <a16:colId xmlns:a16="http://schemas.microsoft.com/office/drawing/2014/main" val="4114848911"/>
                    </a:ext>
                  </a:extLst>
                </a:gridCol>
                <a:gridCol w="485029">
                  <a:extLst>
                    <a:ext uri="{9D8B030D-6E8A-4147-A177-3AD203B41FA5}">
                      <a16:colId xmlns:a16="http://schemas.microsoft.com/office/drawing/2014/main" val="3429877973"/>
                    </a:ext>
                  </a:extLst>
                </a:gridCol>
                <a:gridCol w="898498">
                  <a:extLst>
                    <a:ext uri="{9D8B030D-6E8A-4147-A177-3AD203B41FA5}">
                      <a16:colId xmlns:a16="http://schemas.microsoft.com/office/drawing/2014/main" val="278938637"/>
                    </a:ext>
                  </a:extLst>
                </a:gridCol>
                <a:gridCol w="1079727">
                  <a:extLst>
                    <a:ext uri="{9D8B030D-6E8A-4147-A177-3AD203B41FA5}">
                      <a16:colId xmlns:a16="http://schemas.microsoft.com/office/drawing/2014/main" val="4165430631"/>
                    </a:ext>
                  </a:extLst>
                </a:gridCol>
              </a:tblGrid>
              <a:tr h="38860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G + CHARGE-AF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G + PMH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DM, MI, HF)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CG + Demographics</a:t>
                      </a:r>
                      <a:endParaRPr lang="en-US" sz="10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age, race, smoking)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CG +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itals</a:t>
                      </a:r>
                      <a:endParaRPr lang="en-US" sz="10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000" b="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t</a:t>
                      </a:r>
                      <a:r>
                        <a:rPr lang="en-US" sz="1000" b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wt, BP)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CG only</a:t>
                      </a:r>
                    </a:p>
                  </a:txBody>
                  <a:tcPr marL="67945" marR="6794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ARGE-AF model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ARGE-AF score</a:t>
                      </a:r>
                    </a:p>
                  </a:txBody>
                  <a:tcPr marL="67945" marR="67945" marT="9525" marB="0" anchor="ctr"/>
                </a:tc>
                <a:extLst>
                  <a:ext uri="{0D108BD9-81ED-4DB2-BD59-A6C34878D82A}">
                    <a16:rowId xmlns:a16="http://schemas.microsoft.com/office/drawing/2014/main" val="1346183953"/>
                  </a:ext>
                </a:extLst>
              </a:tr>
              <a:tr h="17655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ROC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3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1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3</a:t>
                      </a:r>
                    </a:p>
                  </a:txBody>
                  <a:tcPr marL="67945" marR="6794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0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9</a:t>
                      </a:r>
                    </a:p>
                  </a:txBody>
                  <a:tcPr marL="67945" marR="67945" marT="9525" marB="0" anchor="ctr"/>
                </a:tc>
                <a:extLst>
                  <a:ext uri="{0D108BD9-81ED-4DB2-BD59-A6C34878D82A}">
                    <a16:rowId xmlns:a16="http://schemas.microsoft.com/office/drawing/2014/main" val="2500965000"/>
                  </a:ext>
                </a:extLst>
              </a:tr>
              <a:tr h="23080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PRC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8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2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4</a:t>
                      </a:r>
                    </a:p>
                  </a:txBody>
                  <a:tcPr marL="67945" marR="6794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8</a:t>
                      </a:r>
                    </a:p>
                  </a:txBody>
                  <a:tcPr marL="67945" marR="67945" marT="9525" marB="0" anchor="ctr"/>
                </a:tc>
                <a:extLst>
                  <a:ext uri="{0D108BD9-81ED-4DB2-BD59-A6C34878D82A}">
                    <a16:rowId xmlns:a16="http://schemas.microsoft.com/office/drawing/2014/main" val="268243846"/>
                  </a:ext>
                </a:extLst>
              </a:tr>
              <a:tr h="17655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ficit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8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0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1</a:t>
                      </a:r>
                    </a:p>
                  </a:txBody>
                  <a:tcPr marL="67945" marR="6794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8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8</a:t>
                      </a:r>
                    </a:p>
                  </a:txBody>
                  <a:tcPr marL="67945" marR="67945" marT="9525" marB="0" anchor="ctr"/>
                </a:tc>
                <a:extLst>
                  <a:ext uri="{0D108BD9-81ED-4DB2-BD59-A6C34878D82A}">
                    <a16:rowId xmlns:a16="http://schemas.microsoft.com/office/drawing/2014/main" val="3447885739"/>
                  </a:ext>
                </a:extLst>
              </a:tr>
              <a:tr h="31716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nsitivity / 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all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2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8</a:t>
                      </a:r>
                    </a:p>
                  </a:txBody>
                  <a:tcPr marL="67945" marR="6794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1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</a:p>
                  </a:txBody>
                  <a:tcPr marL="67945" marR="67945" marT="9525" marB="0" anchor="ctr"/>
                </a:tc>
                <a:extLst>
                  <a:ext uri="{0D108BD9-81ED-4DB2-BD59-A6C34878D82A}">
                    <a16:rowId xmlns:a16="http://schemas.microsoft.com/office/drawing/2014/main" val="2051957414"/>
                  </a:ext>
                </a:extLst>
              </a:tr>
              <a:tr h="44515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cision/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 predictive valu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4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6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7</a:t>
                      </a:r>
                    </a:p>
                  </a:txBody>
                  <a:tcPr marL="67945" marR="6794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5</a:t>
                      </a:r>
                    </a:p>
                  </a:txBody>
                  <a:tcPr marL="67945" marR="67945" marT="9525" marB="0" anchor="ctr"/>
                </a:tc>
                <a:extLst>
                  <a:ext uri="{0D108BD9-81ED-4DB2-BD59-A6C34878D82A}">
                    <a16:rowId xmlns:a16="http://schemas.microsoft.com/office/drawing/2014/main" val="2710073956"/>
                  </a:ext>
                </a:extLst>
              </a:tr>
              <a:tr h="30500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 predictive valu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8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9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2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1</a:t>
                      </a:r>
                    </a:p>
                  </a:txBody>
                  <a:tcPr marL="67945" marR="6794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0</a:t>
                      </a:r>
                    </a:p>
                  </a:txBody>
                  <a:tcPr marL="67945" marR="67945" marT="9525" marB="0" anchor="ctr"/>
                </a:tc>
                <a:extLst>
                  <a:ext uri="{0D108BD9-81ED-4DB2-BD59-A6C34878D82A}">
                    <a16:rowId xmlns:a16="http://schemas.microsoft.com/office/drawing/2014/main" val="2126837865"/>
                  </a:ext>
                </a:extLst>
              </a:tr>
              <a:tr h="45288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tthews Correlation Coefficient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2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2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3</a:t>
                      </a:r>
                    </a:p>
                  </a:txBody>
                  <a:tcPr marL="67945" marR="6794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1</a:t>
                      </a:r>
                    </a:p>
                  </a:txBody>
                  <a:tcPr marL="67945" marR="67945" marT="9525" marB="0" anchor="ctr"/>
                </a:tc>
                <a:extLst>
                  <a:ext uri="{0D108BD9-81ED-4DB2-BD59-A6C34878D82A}">
                    <a16:rowId xmlns:a16="http://schemas.microsoft.com/office/drawing/2014/main" val="2258075336"/>
                  </a:ext>
                </a:extLst>
              </a:tr>
              <a:tr h="17655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urac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67945" marR="6794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4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8</a:t>
                      </a:r>
                    </a:p>
                  </a:txBody>
                  <a:tcPr marL="67945" marR="67945" marT="9525" marB="0" anchor="ctr"/>
                </a:tc>
                <a:extLst>
                  <a:ext uri="{0D108BD9-81ED-4DB2-BD59-A6C34878D82A}">
                    <a16:rowId xmlns:a16="http://schemas.microsoft.com/office/drawing/2014/main" val="2974256487"/>
                  </a:ext>
                </a:extLst>
              </a:tr>
              <a:tr h="17655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 Scor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3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6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5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5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5</a:t>
                      </a:r>
                    </a:p>
                  </a:txBody>
                  <a:tcPr marL="67945" marR="6794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7</a:t>
                      </a:r>
                    </a:p>
                  </a:txBody>
                  <a:tcPr marL="67945" marR="67945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7</a:t>
                      </a:r>
                    </a:p>
                  </a:txBody>
                  <a:tcPr marL="67945" marR="67945" marT="9525" marB="0" anchor="ctr"/>
                </a:tc>
                <a:extLst>
                  <a:ext uri="{0D108BD9-81ED-4DB2-BD59-A6C34878D82A}">
                    <a16:rowId xmlns:a16="http://schemas.microsoft.com/office/drawing/2014/main" val="1149170829"/>
                  </a:ext>
                </a:extLst>
              </a:tr>
            </a:tbl>
          </a:graphicData>
        </a:graphic>
      </p:graphicFrame>
      <p:pic>
        <p:nvPicPr>
          <p:cNvPr id="3074" name="Picture 2">
            <a:extLst>
              <a:ext uri="{FF2B5EF4-FFF2-40B4-BE49-F238E27FC236}">
                <a16:creationId xmlns:a16="http://schemas.microsoft.com/office/drawing/2014/main" id="{2EE9352F-CD2A-EA93-5EE2-1B68BB0A4F5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24083"/>
            <a:ext cx="6858000" cy="4232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4A73992-1E1E-9D40-BE4F-F9F18963A3AC}"/>
              </a:ext>
            </a:extLst>
          </p:cNvPr>
          <p:cNvSpPr txBox="1"/>
          <p:nvPr/>
        </p:nvSpPr>
        <p:spPr>
          <a:xfrm>
            <a:off x="0" y="-30361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F1736FD-D605-5B46-AC0E-2991EFB88259}"/>
              </a:ext>
            </a:extLst>
          </p:cNvPr>
          <p:cNvSpPr txBox="1"/>
          <p:nvPr/>
        </p:nvSpPr>
        <p:spPr>
          <a:xfrm>
            <a:off x="3428998" y="-30362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438A552-1807-C445-AB5A-AD4B0C46E6D8}"/>
              </a:ext>
            </a:extLst>
          </p:cNvPr>
          <p:cNvSpPr txBox="1"/>
          <p:nvPr/>
        </p:nvSpPr>
        <p:spPr>
          <a:xfrm>
            <a:off x="0" y="4576404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58C109E-D274-4843-909D-F79D373F3D0A}"/>
              </a:ext>
            </a:extLst>
          </p:cNvPr>
          <p:cNvSpPr txBox="1"/>
          <p:nvPr/>
        </p:nvSpPr>
        <p:spPr>
          <a:xfrm>
            <a:off x="83854" y="8937784"/>
            <a:ext cx="643850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: Model performance in test set with shuffled CHARGE-AF features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he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ceiver operator characteristic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)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precision recall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urves for each CNN model applied to the test set with shuffled CHARGE-AF features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C)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model performance metrics for all CNN models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pplied to the test set with shuffled CHARGE-AF features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0871075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458C109E-D274-4843-909D-F79D373F3D0A}"/>
              </a:ext>
            </a:extLst>
          </p:cNvPr>
          <p:cNvSpPr txBox="1"/>
          <p:nvPr/>
        </p:nvSpPr>
        <p:spPr>
          <a:xfrm>
            <a:off x="209746" y="5182212"/>
            <a:ext cx="64385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Calibration curve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he calibration curve for the ECG + CHARGE-AF AI-ECG model in the testing set with a corresponding Brier score of 0.174.</a:t>
            </a:r>
            <a:endParaRPr lang="en-US" sz="1200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AE56CF32-0A50-D642-8998-F2234B278429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27"/>
          <a:stretch/>
        </p:blipFill>
        <p:spPr>
          <a:xfrm>
            <a:off x="419493" y="359229"/>
            <a:ext cx="5800725" cy="4533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0138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934</TotalTime>
  <Words>235</Words>
  <Application>Microsoft Macintosh PowerPoint</Application>
  <PresentationFormat>Widescreen</PresentationFormat>
  <Paragraphs>9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banis, Constantine</dc:creator>
  <cp:lastModifiedBy>Tarabanis, Constantine</cp:lastModifiedBy>
  <cp:revision>88</cp:revision>
  <dcterms:created xsi:type="dcterms:W3CDTF">2024-04-28T00:07:48Z</dcterms:created>
  <dcterms:modified xsi:type="dcterms:W3CDTF">2025-07-05T22:40:44Z</dcterms:modified>
</cp:coreProperties>
</file>